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9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78" autoAdjust="0"/>
    <p:restoredTop sz="94660"/>
  </p:normalViewPr>
  <p:slideViewPr>
    <p:cSldViewPr snapToGrid="0">
      <p:cViewPr varScale="1">
        <p:scale>
          <a:sx n="83" d="100"/>
          <a:sy n="83" d="100"/>
        </p:scale>
        <p:origin x="1387" y="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5031AD-63F2-4601-A798-4F994223DCC7}" type="datetimeFigureOut">
              <a:rPr lang="en-CA" smtClean="0"/>
              <a:t>2024-11-28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E9AF2A-679F-4CF2-B6F9-350CAC5300B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955198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3D2A1-C62E-43C8-8D99-2393D3381841}" type="datetimeFigureOut">
              <a:rPr lang="en-CA" smtClean="0"/>
              <a:t>2024-11-2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4DB18-CC9A-4140-BD2F-D33BFA2F3EE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597946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3D2A1-C62E-43C8-8D99-2393D3381841}" type="datetimeFigureOut">
              <a:rPr lang="en-CA" smtClean="0"/>
              <a:t>2024-11-2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4DB18-CC9A-4140-BD2F-D33BFA2F3EE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51923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3D2A1-C62E-43C8-8D99-2393D3381841}" type="datetimeFigureOut">
              <a:rPr lang="en-CA" smtClean="0"/>
              <a:t>2024-11-2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4DB18-CC9A-4140-BD2F-D33BFA2F3EE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05463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3D2A1-C62E-43C8-8D99-2393D3381841}" type="datetimeFigureOut">
              <a:rPr lang="en-CA" smtClean="0"/>
              <a:t>2024-11-2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4DB18-CC9A-4140-BD2F-D33BFA2F3EE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540177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3D2A1-C62E-43C8-8D99-2393D3381841}" type="datetimeFigureOut">
              <a:rPr lang="en-CA" smtClean="0"/>
              <a:t>2024-11-2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4DB18-CC9A-4140-BD2F-D33BFA2F3EE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763850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3D2A1-C62E-43C8-8D99-2393D3381841}" type="datetimeFigureOut">
              <a:rPr lang="en-CA" smtClean="0"/>
              <a:t>2024-11-2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4DB18-CC9A-4140-BD2F-D33BFA2F3EE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277593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3D2A1-C62E-43C8-8D99-2393D3381841}" type="datetimeFigureOut">
              <a:rPr lang="en-CA" smtClean="0"/>
              <a:t>2024-11-28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4DB18-CC9A-4140-BD2F-D33BFA2F3EE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35995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3D2A1-C62E-43C8-8D99-2393D3381841}" type="datetimeFigureOut">
              <a:rPr lang="en-CA" smtClean="0"/>
              <a:t>2024-11-28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4DB18-CC9A-4140-BD2F-D33BFA2F3EE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70598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3D2A1-C62E-43C8-8D99-2393D3381841}" type="datetimeFigureOut">
              <a:rPr lang="en-CA" smtClean="0"/>
              <a:t>2024-11-28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4DB18-CC9A-4140-BD2F-D33BFA2F3EE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855135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3D2A1-C62E-43C8-8D99-2393D3381841}" type="datetimeFigureOut">
              <a:rPr lang="en-CA" smtClean="0"/>
              <a:t>2024-11-2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4DB18-CC9A-4140-BD2F-D33BFA2F3EE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266505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3D2A1-C62E-43C8-8D99-2393D3381841}" type="datetimeFigureOut">
              <a:rPr lang="en-CA" smtClean="0"/>
              <a:t>2024-11-2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4DB18-CC9A-4140-BD2F-D33BFA2F3EE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633980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23D2A1-C62E-43C8-8D99-2393D3381841}" type="datetimeFigureOut">
              <a:rPr lang="en-CA" smtClean="0"/>
              <a:t>2024-11-2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34DB18-CC9A-4140-BD2F-D33BFA2F3EE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058132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418289" y="457200"/>
            <a:ext cx="8287966" cy="5359940"/>
            <a:chOff x="651251" y="2911934"/>
            <a:chExt cx="6312228" cy="3751944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3973411" y="3673809"/>
              <a:ext cx="3751941" cy="2228194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1908299" y="3881668"/>
              <a:ext cx="3751941" cy="1812473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-114793" y="3677978"/>
              <a:ext cx="3751944" cy="2219855"/>
            </a:xfrm>
            <a:prstGeom prst="rect">
              <a:avLst/>
            </a:prstGeom>
          </p:spPr>
        </p:pic>
      </p:grpSp>
      <p:sp>
        <p:nvSpPr>
          <p:cNvPr id="8" name="Rectangle 7"/>
          <p:cNvSpPr/>
          <p:nvPr/>
        </p:nvSpPr>
        <p:spPr>
          <a:xfrm>
            <a:off x="625867" y="656770"/>
            <a:ext cx="3241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A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35284371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3973" y="255930"/>
            <a:ext cx="5035917" cy="5035917"/>
          </a:xfrm>
          <a:prstGeom prst="rect">
            <a:avLst/>
          </a:prstGeom>
        </p:spPr>
      </p:pic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51031256"/>
              </p:ext>
            </p:extLst>
          </p:nvPr>
        </p:nvGraphicFramePr>
        <p:xfrm>
          <a:off x="7253288" y="1982788"/>
          <a:ext cx="1349375" cy="1217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ackager Shell Object" showAsIcon="1" r:id="rId3" imgW="579240" imgH="392040" progId="Package">
                  <p:embed/>
                </p:oleObj>
              </mc:Choice>
              <mc:Fallback>
                <p:oleObj name="Packager Shell Object" showAsIcon="1" r:id="rId3" imgW="579240" imgH="392040" progId="Package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253288" y="1982788"/>
                        <a:ext cx="1349375" cy="12176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Rectangle 2"/>
          <p:cNvSpPr/>
          <p:nvPr/>
        </p:nvSpPr>
        <p:spPr>
          <a:xfrm>
            <a:off x="674504" y="255930"/>
            <a:ext cx="3241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B</a:t>
            </a:r>
            <a:endParaRPr lang="en-CA" dirty="0"/>
          </a:p>
        </p:txBody>
      </p:sp>
      <p:sp>
        <p:nvSpPr>
          <p:cNvPr id="4" name="Rectangle 3"/>
          <p:cNvSpPr/>
          <p:nvPr/>
        </p:nvSpPr>
        <p:spPr>
          <a:xfrm>
            <a:off x="2432" y="5291847"/>
            <a:ext cx="9141568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lementary Figure S1. Adaptation of the TMS technology for use in mice</a:t>
            </a:r>
            <a:r>
              <a:rPr lang="en-US" dirty="0"/>
              <a:t>. Shown is the </a:t>
            </a:r>
            <a:r>
              <a:rPr lang="en-US" dirty="0" err="1"/>
              <a:t>dTMS</a:t>
            </a:r>
            <a:r>
              <a:rPr lang="en-US" dirty="0"/>
              <a:t>  apparatus adapted by </a:t>
            </a:r>
            <a:r>
              <a:rPr lang="en-US" dirty="0" err="1"/>
              <a:t>Brainsway</a:t>
            </a:r>
            <a:r>
              <a:rPr lang="en-US" dirty="0"/>
              <a:t> for extra-cranial stimulation of mice (</a:t>
            </a:r>
            <a:r>
              <a:rPr lang="en-US" b="1" dirty="0"/>
              <a:t>A</a:t>
            </a:r>
            <a:r>
              <a:rPr lang="en-US" dirty="0"/>
              <a:t>).  </a:t>
            </a:r>
          </a:p>
          <a:p>
            <a:r>
              <a:rPr lang="en-US" dirty="0"/>
              <a:t>TMS may be applied as a single pulse, or repeatedly (</a:t>
            </a:r>
            <a:r>
              <a:rPr lang="en-US" dirty="0" err="1"/>
              <a:t>rTMS</a:t>
            </a:r>
            <a:r>
              <a:rPr lang="en-US" dirty="0"/>
              <a:t>), with variation in intensity, site and orientation of the magnetic field. Deep TMS (</a:t>
            </a:r>
            <a:r>
              <a:rPr lang="en-US" dirty="0" err="1"/>
              <a:t>dTMS</a:t>
            </a:r>
            <a:r>
              <a:rPr lang="en-US" dirty="0"/>
              <a:t>) is a novel form of TMS that uses specialized coils (seen in photograph</a:t>
            </a:r>
            <a:r>
              <a:rPr lang="en-US" b="1" dirty="0"/>
              <a:t>, </a:t>
            </a:r>
            <a:r>
              <a:rPr lang="en-US" b="1" dirty="0" err="1"/>
              <a:t>A&amp;B</a:t>
            </a:r>
            <a:r>
              <a:rPr lang="en-US" dirty="0"/>
              <a:t>) designed to reach broader and deeper areas within the brain. 	</a:t>
            </a:r>
          </a:p>
        </p:txBody>
      </p:sp>
    </p:spTree>
    <p:extLst>
      <p:ext uri="{BB962C8B-B14F-4D97-AF65-F5344CB8AC3E}">
        <p14:creationId xmlns:p14="http://schemas.microsoft.com/office/powerpoint/2010/main" val="11891550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3</TotalTime>
  <Words>95</Words>
  <Application>Microsoft Office PowerPoint</Application>
  <PresentationFormat>On-screen Show (4:3)</PresentationFormat>
  <Paragraphs>4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ackag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. Penina Brodt</dc:creator>
  <cp:lastModifiedBy>MDPI</cp:lastModifiedBy>
  <cp:revision>13</cp:revision>
  <dcterms:created xsi:type="dcterms:W3CDTF">2024-08-21T00:39:21Z</dcterms:created>
  <dcterms:modified xsi:type="dcterms:W3CDTF">2024-11-28T10:56:10Z</dcterms:modified>
</cp:coreProperties>
</file>